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36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/4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Fig.14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85794"/>
            <a:ext cx="9144000" cy="445841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-71470" y="285728"/>
            <a:ext cx="721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.1 </a:t>
            </a:r>
            <a:r>
              <a:rPr lang="en-US" b="1" dirty="0" err="1" smtClean="0">
                <a:latin typeface="Times New Roman" pitchFamily="18" charset="0"/>
                <a:cs typeface="Times New Roman" pitchFamily="18" charset="0"/>
              </a:rPr>
              <a:t>Histopathological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 analysis of organs stained with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H&amp;E 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98" name="Rectangle 2"/>
          <p:cNvSpPr>
            <a:spLocks noChangeArrowheads="1"/>
          </p:cNvSpPr>
          <p:nvPr/>
        </p:nvSpPr>
        <p:spPr bwMode="auto">
          <a:xfrm>
            <a:off x="0" y="5357826"/>
            <a:ext cx="8805424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Histopathology showing normal morphology from the acute toxicity test. (A) heart, (B) liver, (C) spleen,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 (D) lung, (E) kidney, (F) pancreas; scale bar = 100μm</a:t>
            </a:r>
            <a:endParaRPr kumimoji="0" lang="en-US" altLang="zh-CN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Fig.15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" y="714356"/>
            <a:ext cx="9144000" cy="4486807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0" y="142852"/>
            <a:ext cx="671514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.2 </a:t>
            </a:r>
            <a:r>
              <a:rPr lang="en-US" b="1" dirty="0" err="1" smtClean="0">
                <a:latin typeface="Times New Roman" pitchFamily="18" charset="0"/>
                <a:cs typeface="Times New Roman" pitchFamily="18" charset="0"/>
              </a:rPr>
              <a:t>Histopathological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 analysis of organs stained with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H&amp;E 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-32015" y="5344555"/>
            <a:ext cx="8533105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Histopathology showing normal morphology from the acute toxicity test. (A) stomach, (B)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rgbClr val="434343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 jejunum,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(C) duodenum, (D) uterus, (E) ovaries, (F) </a:t>
            </a:r>
            <a:r>
              <a:rPr kumimoji="0" lang="en-US" altLang="zh-CN" sz="16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orchis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; scale bar = 100 </a:t>
            </a:r>
            <a:r>
              <a:rPr kumimoji="0" lang="en-US" altLang="zh-CN" sz="16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μm</a:t>
            </a:r>
            <a:endParaRPr kumimoji="0" lang="en-US" altLang="zh-CN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Fig.16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19474"/>
            <a:ext cx="9144000" cy="4566914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0" y="142852"/>
            <a:ext cx="64293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.3 </a:t>
            </a:r>
            <a:r>
              <a:rPr lang="en-US" b="1" dirty="0" err="1" smtClean="0">
                <a:latin typeface="Times New Roman" pitchFamily="18" charset="0"/>
                <a:cs typeface="Times New Roman" pitchFamily="18" charset="0"/>
              </a:rPr>
              <a:t>Histopathological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 analysis of organs stained with H&amp;E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-13701" y="5415993"/>
            <a:ext cx="8300477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Histopathology showing normal morphology from eight dead rats. (A) heart, (B) liver, (C) spleen,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(D) lung, (E) kidney, (F) pancreas; scale bar = 100μm</a:t>
            </a:r>
            <a:endParaRPr kumimoji="0" lang="en-US" altLang="zh-CN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Fig.17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71480"/>
            <a:ext cx="9144000" cy="4597657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0" y="130710"/>
            <a:ext cx="657226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.4 </a:t>
            </a:r>
            <a:r>
              <a:rPr lang="en-US" b="1" dirty="0" err="1" smtClean="0">
                <a:latin typeface="Times New Roman" pitchFamily="18" charset="0"/>
                <a:cs typeface="Times New Roman" pitchFamily="18" charset="0"/>
              </a:rPr>
              <a:t>Histopathological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 analysis of organs stained with H&amp;E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-47278" y="5429264"/>
            <a:ext cx="7976864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Histopathology showing normal morphology from eight dead rats. (A) stomach, (B)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rgbClr val="434343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 jejunum,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(C) duodenum, (D) uterus, (E) ovaries, (F) </a:t>
            </a:r>
            <a:r>
              <a:rPr kumimoji="0" lang="en-US" altLang="zh-CN" sz="16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orchis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; scale bar = 100 </a:t>
            </a:r>
            <a:r>
              <a:rPr kumimoji="0" lang="en-US" altLang="zh-CN" sz="16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μm</a:t>
            </a:r>
            <a:endParaRPr kumimoji="0" lang="en-US" altLang="zh-CN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55</Words>
  <PresentationFormat>全屏显示(4:3)</PresentationFormat>
  <Paragraphs>12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幻灯片 1</vt:lpstr>
      <vt:lpstr>幻灯片 2</vt:lpstr>
      <vt:lpstr>幻灯片 3</vt:lpstr>
      <vt:lpstr>幻灯片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hp</dc:creator>
  <cp:lastModifiedBy>hp</cp:lastModifiedBy>
  <cp:revision>1</cp:revision>
  <dcterms:created xsi:type="dcterms:W3CDTF">2018-04-15T08:14:09Z</dcterms:created>
  <dcterms:modified xsi:type="dcterms:W3CDTF">2018-04-15T08:34:23Z</dcterms:modified>
</cp:coreProperties>
</file>